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  <p:sldId id="258" r:id="rId4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14"/>
    <p:restoredTop sz="94541"/>
  </p:normalViewPr>
  <p:slideViewPr>
    <p:cSldViewPr snapToObjects="1">
      <p:cViewPr varScale="1">
        <p:scale>
          <a:sx n="124" d="100"/>
          <a:sy n="124" d="100"/>
        </p:scale>
        <p:origin x="202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C6FBF-3F84-7646-BB0E-56E5175E493A}" type="datetimeFigureOut">
              <a:rPr lang="fr-FR" smtClean="0"/>
              <a:t>03/03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463CD-BB42-BA42-BE1C-2CCAF6821ECC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DAA6C45C-9EF5-E244-AF98-3D0B7BB07B19}"/>
              </a:ext>
            </a:extLst>
          </p:cNvPr>
          <p:cNvSpPr txBox="1"/>
          <p:nvPr/>
        </p:nvSpPr>
        <p:spPr>
          <a:xfrm>
            <a:off x="152756" y="5582552"/>
            <a:ext cx="899124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1 :</a:t>
            </a:r>
            <a:r>
              <a:rPr lang="en-US" sz="1200" dirty="0"/>
              <a:t> </a:t>
            </a:r>
            <a:r>
              <a:rPr lang="en-US" sz="1200" b="1" dirty="0"/>
              <a:t>Position of W361 on the CFTR 3D structure (model of the open channel). </a:t>
            </a:r>
            <a:r>
              <a:rPr lang="fr-FR" sz="1200" b="1" dirty="0"/>
              <a:t> </a:t>
            </a:r>
            <a:r>
              <a:rPr lang="en-US" sz="1200" dirty="0"/>
              <a:t>(A) Position of W361 on the model </a:t>
            </a:r>
          </a:p>
          <a:p>
            <a:r>
              <a:rPr lang="en-US" sz="1200" dirty="0"/>
              <a:t>of the open channel (Hoffmann et al., 2018). The end of the lasso structure is shown in purple. The amino acids not reported in italics are</a:t>
            </a:r>
          </a:p>
          <a:p>
            <a:r>
              <a:rPr lang="en-US" sz="1200" dirty="0"/>
              <a:t> affected by disease-associated mutations. Amino acids in green and red correspond to mild and severe class-2 mutations respectively, as </a:t>
            </a:r>
          </a:p>
          <a:p>
            <a:r>
              <a:rPr lang="en-US" sz="1200" dirty="0"/>
              <a:t>discussed in the text. (B) The same 3D structure and amino acids after MD simulations in presence of lipids. The two POPC molecules, whose </a:t>
            </a:r>
          </a:p>
          <a:p>
            <a:r>
              <a:rPr lang="en-US" sz="1200" dirty="0"/>
              <a:t>acyl chains filled the groove formed by the elbow helix, TM1, TM3 and TM6, are shown. (C) Surface representation of the CFTR 3D structure, </a:t>
            </a:r>
          </a:p>
          <a:p>
            <a:r>
              <a:rPr lang="en-US" sz="1200" dirty="0"/>
              <a:t>highlighting the groove. </a:t>
            </a:r>
            <a:endParaRPr lang="fr-FR" sz="1200" dirty="0"/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7161DCE3-980B-564E-8E86-1965C1DAE3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2000" y="0"/>
            <a:ext cx="7200000" cy="5582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16801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CAcryo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7200"/>
            <a:ext cx="4480560" cy="5120640"/>
          </a:xfrm>
          <a:prstGeom prst="rect">
            <a:avLst/>
          </a:prstGeom>
        </p:spPr>
      </p:pic>
      <p:pic>
        <p:nvPicPr>
          <p:cNvPr id="5" name="Image 4" descr="CAmod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0560" y="457200"/>
            <a:ext cx="4480560" cy="512064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8710294F-50AB-A64A-877C-E781BA2786DD}"/>
              </a:ext>
            </a:extLst>
          </p:cNvPr>
          <p:cNvSpPr txBox="1"/>
          <p:nvPr/>
        </p:nvSpPr>
        <p:spPr>
          <a:xfrm>
            <a:off x="394281" y="5805264"/>
            <a:ext cx="82971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2:</a:t>
            </a:r>
            <a:r>
              <a:rPr lang="en-US" sz="1200" dirty="0"/>
              <a:t> Maps of the contacts established by W361 (left : cryo-EM 3D structures, right : model of the open form). </a:t>
            </a:r>
          </a:p>
          <a:p>
            <a:r>
              <a:rPr lang="en-US" sz="1200" dirty="0"/>
              <a:t>MD simulations performed over 125 ns.</a:t>
            </a:r>
            <a:endParaRPr lang="fr-FR" sz="1200" dirty="0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376439BA-7B8E-9C47-86D0-6B75028667FF}"/>
              </a:ext>
            </a:extLst>
          </p:cNvPr>
          <p:cNvSpPr txBox="1"/>
          <p:nvPr/>
        </p:nvSpPr>
        <p:spPr>
          <a:xfrm>
            <a:off x="251520" y="31599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AF8B9854-A3F6-E746-8FCC-C590DEE3EA61}"/>
              </a:ext>
            </a:extLst>
          </p:cNvPr>
          <p:cNvSpPr txBox="1"/>
          <p:nvPr/>
        </p:nvSpPr>
        <p:spPr>
          <a:xfrm>
            <a:off x="4694798" y="31599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 13">
            <a:extLst>
              <a:ext uri="{FF2B5EF4-FFF2-40B4-BE49-F238E27FC236}">
                <a16:creationId xmlns:a16="http://schemas.microsoft.com/office/drawing/2014/main" id="{0B894D5F-841E-FB4E-B76C-67D190CB9F4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9950" b="12851"/>
          <a:stretch/>
        </p:blipFill>
        <p:spPr>
          <a:xfrm>
            <a:off x="179512" y="507289"/>
            <a:ext cx="5686672" cy="5400000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3F952EE1-199B-454F-8116-8C7B9C79F9ED}"/>
              </a:ext>
            </a:extLst>
          </p:cNvPr>
          <p:cNvSpPr txBox="1"/>
          <p:nvPr/>
        </p:nvSpPr>
        <p:spPr>
          <a:xfrm>
            <a:off x="88444" y="6237312"/>
            <a:ext cx="822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/>
              <a:t>Supplementary figure </a:t>
            </a:r>
            <a:r>
              <a:rPr lang="en-US" sz="1200" b="1" dirty="0"/>
              <a:t>3 :</a:t>
            </a:r>
            <a:r>
              <a:rPr lang="en-US" sz="1200" dirty="0"/>
              <a:t> Similar conserved features of the W361 neighborhood, highlighted along two different MD simulations </a:t>
            </a:r>
          </a:p>
          <a:p>
            <a:r>
              <a:rPr lang="en-US" sz="1200" dirty="0"/>
              <a:t>using cryo-EM 3D structure.</a:t>
            </a:r>
            <a:endParaRPr lang="fr-FR" sz="1200" dirty="0"/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C78D0619-BAFA-614E-AEAF-96FDC711D7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6184" y="383989"/>
            <a:ext cx="2520000" cy="288000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F3A462BD-3A9C-A142-A48D-712C5D8295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03333" y="3263989"/>
            <a:ext cx="252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66097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202</Words>
  <Application>Microsoft Macintosh PowerPoint</Application>
  <PresentationFormat>Affichage à l'écran (4:3)</PresentationFormat>
  <Paragraphs>12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</vt:vector>
  </TitlesOfParts>
  <Company>CNR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Isabelle</dc:creator>
  <cp:lastModifiedBy>Isabelle Callebaut</cp:lastModifiedBy>
  <cp:revision>12</cp:revision>
  <dcterms:created xsi:type="dcterms:W3CDTF">2020-01-03T13:49:38Z</dcterms:created>
  <dcterms:modified xsi:type="dcterms:W3CDTF">2020-03-03T18:37:05Z</dcterms:modified>
</cp:coreProperties>
</file>